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67" d="100"/>
          <a:sy n="67" d="100"/>
        </p:scale>
        <p:origin x="78" y="1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8B9CC-96F8-44D2-AF0A-96381C86A7FE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AC5AA-F458-410E-AACA-8BF6169C3DF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90504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8B9CC-96F8-44D2-AF0A-96381C86A7FE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AC5AA-F458-410E-AACA-8BF6169C3DF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04617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8B9CC-96F8-44D2-AF0A-96381C86A7FE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AC5AA-F458-410E-AACA-8BF6169C3DF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45841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8B9CC-96F8-44D2-AF0A-96381C86A7FE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AC5AA-F458-410E-AACA-8BF6169C3DF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08661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8B9CC-96F8-44D2-AF0A-96381C86A7FE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AC5AA-F458-410E-AACA-8BF6169C3DF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188934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8B9CC-96F8-44D2-AF0A-96381C86A7FE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AC5AA-F458-410E-AACA-8BF6169C3DF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275555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8B9CC-96F8-44D2-AF0A-96381C86A7FE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AC5AA-F458-410E-AACA-8BF6169C3DF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89243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8B9CC-96F8-44D2-AF0A-96381C86A7FE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AC5AA-F458-410E-AACA-8BF6169C3DF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90768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8B9CC-96F8-44D2-AF0A-96381C86A7FE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AC5AA-F458-410E-AACA-8BF6169C3DF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87820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8B9CC-96F8-44D2-AF0A-96381C86A7FE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AC5AA-F458-410E-AACA-8BF6169C3DF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546086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8B9CC-96F8-44D2-AF0A-96381C86A7FE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CAC5AA-F458-410E-AACA-8BF6169C3DF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382175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58B9CC-96F8-44D2-AF0A-96381C86A7FE}" type="datetimeFigureOut">
              <a:rPr lang="it-IT" smtClean="0"/>
              <a:t>10/12/2021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CAC5AA-F458-410E-AACA-8BF6169C3DF5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438053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96452" y="1854708"/>
            <a:ext cx="3805935" cy="2854452"/>
          </a:xfrm>
          <a:prstGeom prst="rect">
            <a:avLst/>
          </a:prstGeom>
        </p:spPr>
      </p:pic>
      <p:pic>
        <p:nvPicPr>
          <p:cNvPr id="5" name="Immagin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33723" y="1854708"/>
            <a:ext cx="3805936" cy="2854452"/>
          </a:xfrm>
          <a:prstGeom prst="rect">
            <a:avLst/>
          </a:prstGeom>
        </p:spPr>
      </p:pic>
      <p:pic>
        <p:nvPicPr>
          <p:cNvPr id="7" name="Immagine 6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994" y="1854708"/>
            <a:ext cx="3805936" cy="2854452"/>
          </a:xfrm>
          <a:prstGeom prst="rect">
            <a:avLst/>
          </a:prstGeom>
        </p:spPr>
      </p:pic>
      <p:sp>
        <p:nvSpPr>
          <p:cNvPr id="8" name="Rettangolo 7"/>
          <p:cNvSpPr/>
          <p:nvPr/>
        </p:nvSpPr>
        <p:spPr>
          <a:xfrm>
            <a:off x="292608" y="341165"/>
            <a:ext cx="11494007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.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The field trial was conducted at Maricopa Agricultural Center (southward view) lat. 33.070° N, long. 111.974° W, elev. 360 m on a Casa Grande sandy loam soil (fine-loamy, mixed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eractiv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pertherm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ypi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atrargid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Durum Panel included 248 durum wheat elite accessions representative of a large portion of the genetic diversity present in the most important improved durum wheat gene pools. The pictures refer to three different days after planting (DAP) of the Durum Panel.</a:t>
            </a:r>
          </a:p>
          <a:p>
            <a:pPr algn="just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Rettangolo 8"/>
          <p:cNvSpPr/>
          <p:nvPr/>
        </p:nvSpPr>
        <p:spPr>
          <a:xfrm>
            <a:off x="70994" y="1334121"/>
            <a:ext cx="444352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it-IT" sz="2800" b="1" cap="none" spc="0" dirty="0">
                <a:ln w="0"/>
                <a:solidFill>
                  <a:srgbClr val="C0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0" name="Rettangolo 9"/>
          <p:cNvSpPr/>
          <p:nvPr/>
        </p:nvSpPr>
        <p:spPr>
          <a:xfrm>
            <a:off x="4220597" y="1274788"/>
            <a:ext cx="423514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it-IT" sz="2800" b="1" dirty="0">
                <a:ln w="0"/>
                <a:solidFill>
                  <a:srgbClr val="C0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it-IT" sz="2800" b="1" cap="none" spc="0" dirty="0">
              <a:ln w="0"/>
              <a:solidFill>
                <a:srgbClr val="C0000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ttangolo 10"/>
          <p:cNvSpPr/>
          <p:nvPr/>
        </p:nvSpPr>
        <p:spPr>
          <a:xfrm>
            <a:off x="8186033" y="1331488"/>
            <a:ext cx="444353" cy="523220"/>
          </a:xfrm>
          <a:prstGeom prst="rect">
            <a:avLst/>
          </a:prstGeom>
          <a:noFill/>
        </p:spPr>
        <p:txBody>
          <a:bodyPr wrap="none" lIns="91440" tIns="45720" rIns="91440" bIns="45720">
            <a:spAutoFit/>
          </a:bodyPr>
          <a:lstStyle/>
          <a:p>
            <a:pPr algn="ctr"/>
            <a:r>
              <a:rPr lang="it-IT" sz="2800" b="1" dirty="0">
                <a:ln w="0"/>
                <a:solidFill>
                  <a:srgbClr val="C00000"/>
                </a:solidFill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it-IT" sz="2800" b="1" cap="none" spc="0" dirty="0">
              <a:ln w="0"/>
              <a:solidFill>
                <a:srgbClr val="C00000"/>
              </a:solidFill>
              <a:effectLst>
                <a:outerShdw blurRad="38100" dist="19050" dir="2700000" algn="tl" rotWithShape="0">
                  <a:schemeClr val="dk1">
                    <a:alpha val="40000"/>
                  </a:schemeClr>
                </a:outerShdw>
              </a:effectLst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Rettangolo 11"/>
          <p:cNvSpPr/>
          <p:nvPr/>
        </p:nvSpPr>
        <p:spPr>
          <a:xfrm>
            <a:off x="515346" y="5087215"/>
            <a:ext cx="967857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228600" indent="-228600">
              <a:buAutoNum type="alphaUcParenR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 February 2018 (92 DAP) - full irrigation conditions </a:t>
            </a:r>
          </a:p>
          <a:p>
            <a:pPr marL="228600" indent="-228600">
              <a:buAutoNum type="alphaUcParenR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 March 2018 (98 DAP) - full irrigation conditions </a:t>
            </a:r>
          </a:p>
          <a:p>
            <a:pPr marL="228600" indent="-228600">
              <a:buAutoNum type="alphaUcParenR"/>
            </a:pP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9 March 2018 (121 DAP) – drought  </a:t>
            </a:r>
          </a:p>
          <a:p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580058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34</TotalTime>
  <Words>130</Words>
  <Application>Microsoft Office PowerPoint</Application>
  <PresentationFormat>Widescreen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i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Giuseppe Emanuele Condorelli</dc:creator>
  <cp:lastModifiedBy>Giuseppe CONDORELLI</cp:lastModifiedBy>
  <cp:revision>10</cp:revision>
  <dcterms:created xsi:type="dcterms:W3CDTF">2018-07-25T07:08:29Z</dcterms:created>
  <dcterms:modified xsi:type="dcterms:W3CDTF">2021-12-10T16:40:54Z</dcterms:modified>
</cp:coreProperties>
</file>